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67" r:id="rId3"/>
    <p:sldId id="268" r:id="rId4"/>
    <p:sldId id="269" r:id="rId5"/>
    <p:sldId id="262" r:id="rId6"/>
    <p:sldId id="263" r:id="rId7"/>
    <p:sldId id="264" r:id="rId8"/>
    <p:sldId id="265" r:id="rId9"/>
  </p:sldIdLst>
  <p:sldSz cx="6858000" cy="12192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11" userDrawn="1">
          <p15:clr>
            <a:srgbClr val="A4A3A4"/>
          </p15:clr>
        </p15:guide>
        <p15:guide id="2" pos="5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4"/>
    <p:restoredTop sz="94655"/>
  </p:normalViewPr>
  <p:slideViewPr>
    <p:cSldViewPr snapToGrid="0" snapToObjects="1">
      <p:cViewPr varScale="1">
        <p:scale>
          <a:sx n="87" d="100"/>
          <a:sy n="87" d="100"/>
        </p:scale>
        <p:origin x="1560" y="208"/>
      </p:cViewPr>
      <p:guideLst>
        <p:guide orient="horz" pos="6811"/>
        <p:guide pos="55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5010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761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1119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407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5600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0130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433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9481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2317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8901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2364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A8DF8-60FB-7045-9A49-B843F1AE9AF5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1E33D-3347-044F-9026-5B5EB71C5A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9563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4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>
            <a:extLst>
              <a:ext uri="{FF2B5EF4-FFF2-40B4-BE49-F238E27FC236}">
                <a16:creationId xmlns:a16="http://schemas.microsoft.com/office/drawing/2014/main" id="{6D9649AA-DCFD-3446-AEF6-74CE2B3FD284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PRORP2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2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7E206D3D-1D65-3249-BD1B-C2D74A5558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3" t="7644" r="-273" b="5286"/>
            <a:stretch/>
          </p:blipFill>
          <p:spPr>
            <a:xfrm>
              <a:off x="1846825" y="1326410"/>
              <a:ext cx="3234840" cy="2540471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C5428657-DC6B-7441-9821-0AB1506826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2740" b="19895"/>
            <a:stretch/>
          </p:blipFill>
          <p:spPr>
            <a:xfrm>
              <a:off x="1828185" y="4409399"/>
              <a:ext cx="3207582" cy="2516184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05F6B161-BA58-FA46-9FD8-380F0A853E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2305" b="13602"/>
            <a:stretch/>
          </p:blipFill>
          <p:spPr>
            <a:xfrm>
              <a:off x="1799539" y="7477614"/>
              <a:ext cx="3206165" cy="25631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58952042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>
            <a:extLst>
              <a:ext uri="{FF2B5EF4-FFF2-40B4-BE49-F238E27FC236}">
                <a16:creationId xmlns:a16="http://schemas.microsoft.com/office/drawing/2014/main" id="{710F8764-067C-054E-B4DD-ABFFCAFBE432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PRORP2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4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3CA6EF33-6ACB-8A4E-A0B6-9C6FE73203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3977" b="6352"/>
            <a:stretch/>
          </p:blipFill>
          <p:spPr>
            <a:xfrm>
              <a:off x="1875150" y="1324878"/>
              <a:ext cx="3215611" cy="2542004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62EF7159-AF6A-3948-88C7-01B12167AA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32000"/>
                      </a14:imgEffect>
                    </a14:imgLayer>
                  </a14:imgProps>
                </a:ext>
              </a:extLst>
            </a:blip>
            <a:srcRect t="12580" b="9604"/>
            <a:stretch/>
          </p:blipFill>
          <p:spPr>
            <a:xfrm>
              <a:off x="1824881" y="4424038"/>
              <a:ext cx="3220850" cy="2522811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EDCD5716-ACAC-7A41-B298-18C095134C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6000"/>
                      </a14:imgEffect>
                    </a14:imgLayer>
                  </a14:imgProps>
                </a:ext>
              </a:extLst>
            </a:blip>
            <a:srcRect t="11128" b="10422"/>
            <a:stretch/>
          </p:blipFill>
          <p:spPr>
            <a:xfrm>
              <a:off x="1808658" y="7460353"/>
              <a:ext cx="3191102" cy="25697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04243813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>
            <a:extLst>
              <a:ext uri="{FF2B5EF4-FFF2-40B4-BE49-F238E27FC236}">
                <a16:creationId xmlns:a16="http://schemas.microsoft.com/office/drawing/2014/main" id="{825CD819-8D06-7340-9031-622227D6F15C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PRORP2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8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340D948F-9619-0F45-8EFC-580CEF4163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2901" b="2739"/>
            <a:stretch/>
          </p:blipFill>
          <p:spPr>
            <a:xfrm>
              <a:off x="1838843" y="1341184"/>
              <a:ext cx="3256184" cy="2525697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E5B5F5CD-3FF0-4346-A58A-F43C70A4F6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3338" b="7291"/>
            <a:stretch/>
          </p:blipFill>
          <p:spPr>
            <a:xfrm>
              <a:off x="1829234" y="4402772"/>
              <a:ext cx="3199531" cy="2522812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9EB1B9D3-F282-C241-823F-5E972696C9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2666" b="16585"/>
            <a:stretch/>
          </p:blipFill>
          <p:spPr>
            <a:xfrm>
              <a:off x="1793026" y="7470987"/>
              <a:ext cx="3222812" cy="251280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14006696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e 12">
            <a:extLst>
              <a:ext uri="{FF2B5EF4-FFF2-40B4-BE49-F238E27FC236}">
                <a16:creationId xmlns:a16="http://schemas.microsoft.com/office/drawing/2014/main" id="{B05FF41D-12D7-DE43-9451-F8F92F5A7D3D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PRORP2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12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2F874160-8082-CA46-AB73-ADF8A9CE6A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797" b="16186"/>
            <a:stretch/>
          </p:blipFill>
          <p:spPr>
            <a:xfrm>
              <a:off x="1863603" y="1341184"/>
              <a:ext cx="3194791" cy="2525697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EBE82272-25FD-E84E-8F0B-450EED746F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7131" b="23920"/>
            <a:stretch/>
          </p:blipFill>
          <p:spPr>
            <a:xfrm>
              <a:off x="1848726" y="4402772"/>
              <a:ext cx="3188159" cy="2522811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B5BEC341-362A-6B48-940A-1B3BBA344E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6542" b="11227"/>
            <a:stretch/>
          </p:blipFill>
          <p:spPr>
            <a:xfrm>
              <a:off x="1806551" y="7470986"/>
              <a:ext cx="3213657" cy="256560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91232471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>
            <a:extLst>
              <a:ext uri="{FF2B5EF4-FFF2-40B4-BE49-F238E27FC236}">
                <a16:creationId xmlns:a16="http://schemas.microsoft.com/office/drawing/2014/main" id="{28F7FE31-8168-7946-9537-A00701A52014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</a:t>
              </a:r>
              <a:r>
                <a:rPr kumimoji="0" lang="en-GB" altLang="fr-FR" sz="1000" b="1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ytoRP</a:t>
              </a:r>
              <a:endParaRPr kumimoji="0" lang="en-GB" altLang="fr-FR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2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69BF2357-6136-C841-A127-F02CD14612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3434" b="7753"/>
            <a:stretch/>
          </p:blipFill>
          <p:spPr>
            <a:xfrm>
              <a:off x="1864859" y="1324877"/>
              <a:ext cx="3192279" cy="2532491"/>
            </a:xfrm>
            <a:prstGeom prst="rect">
              <a:avLst/>
            </a:prstGeom>
          </p:spPr>
        </p:pic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07A8DB30-4DE1-4B46-9A27-432D59E1F7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3707" b="11140"/>
            <a:stretch/>
          </p:blipFill>
          <p:spPr>
            <a:xfrm>
              <a:off x="1837729" y="4409400"/>
              <a:ext cx="3193864" cy="2516184"/>
            </a:xfrm>
            <a:prstGeom prst="rect">
              <a:avLst/>
            </a:prstGeom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6B16710F-942C-D443-A37C-5540C8EAD9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3000"/>
                      </a14:imgEffect>
                    </a14:imgLayer>
                  </a14:imgProps>
                </a:ext>
              </a:extLst>
            </a:blip>
            <a:srcRect t="3805" b="28258"/>
            <a:stretch/>
          </p:blipFill>
          <p:spPr>
            <a:xfrm>
              <a:off x="1792407" y="7490385"/>
              <a:ext cx="3212472" cy="25148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32936246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>
            <a:extLst>
              <a:ext uri="{FF2B5EF4-FFF2-40B4-BE49-F238E27FC236}">
                <a16:creationId xmlns:a16="http://schemas.microsoft.com/office/drawing/2014/main" id="{7CDD4436-4CEA-4B49-A2F9-AB36ECB1F3AA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</a:t>
              </a:r>
              <a:r>
                <a:rPr kumimoji="0" lang="en-GB" altLang="fr-FR" sz="1000" b="1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ytoRP</a:t>
              </a:r>
              <a:endParaRPr kumimoji="0" lang="en-GB" altLang="fr-FR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4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8B2AF03C-7221-5B4B-A9FA-A20D624E42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6328" b="21314"/>
            <a:stretch/>
          </p:blipFill>
          <p:spPr>
            <a:xfrm>
              <a:off x="1865102" y="1324877"/>
              <a:ext cx="3191794" cy="2542004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519D6A2A-5490-5841-8EE3-7C9B89A4F6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5925" b="23602"/>
            <a:stretch/>
          </p:blipFill>
          <p:spPr>
            <a:xfrm>
              <a:off x="1837729" y="4409398"/>
              <a:ext cx="3198038" cy="2516185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F5786654-E6B4-C34E-A5AA-9F9B4A3C21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9777" b="25261"/>
            <a:stretch/>
          </p:blipFill>
          <p:spPr>
            <a:xfrm>
              <a:off x="1801366" y="7477614"/>
              <a:ext cx="3219132" cy="255898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66401985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>
            <a:extLst>
              <a:ext uri="{FF2B5EF4-FFF2-40B4-BE49-F238E27FC236}">
                <a16:creationId xmlns:a16="http://schemas.microsoft.com/office/drawing/2014/main" id="{A21E8BF4-BABA-DD4B-BD14-944E840A8B9A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</a:t>
              </a:r>
              <a:r>
                <a:rPr kumimoji="0" lang="en-GB" altLang="fr-FR" sz="1000" b="1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ytoRP</a:t>
              </a:r>
              <a:endParaRPr kumimoji="0" lang="en-GB" altLang="fr-FR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8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E880926A-C8D1-134D-BD13-2E124FE98F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69" t="13588" r="-769" b="7040"/>
            <a:stretch/>
          </p:blipFill>
          <p:spPr>
            <a:xfrm>
              <a:off x="1903689" y="1341185"/>
              <a:ext cx="3203418" cy="2525696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6EF49824-1D9F-7F4D-B82C-5701E90A03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0334" b="19109"/>
            <a:stretch/>
          </p:blipFill>
          <p:spPr>
            <a:xfrm>
              <a:off x="1837729" y="4402772"/>
              <a:ext cx="3198038" cy="2522812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C2D2DFB3-857D-254F-81F2-3A1C317AA4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21569"/>
            <a:stretch/>
          </p:blipFill>
          <p:spPr>
            <a:xfrm>
              <a:off x="1805630" y="7477614"/>
              <a:ext cx="3221596" cy="25631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76007378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>
            <a:extLst>
              <a:ext uri="{FF2B5EF4-FFF2-40B4-BE49-F238E27FC236}">
                <a16:creationId xmlns:a16="http://schemas.microsoft.com/office/drawing/2014/main" id="{59BF7421-E9D5-534A-A376-F894B5E1186C}"/>
              </a:ext>
            </a:extLst>
          </p:cNvPr>
          <p:cNvGrpSpPr/>
          <p:nvPr/>
        </p:nvGrpSpPr>
        <p:grpSpPr>
          <a:xfrm>
            <a:off x="636459" y="295527"/>
            <a:ext cx="4811859" cy="9745189"/>
            <a:chOff x="636459" y="295527"/>
            <a:chExt cx="4811859" cy="9745189"/>
          </a:xfrm>
        </p:grpSpPr>
        <p:sp>
          <p:nvSpPr>
            <p:cNvPr id="91" name="Rectangle 3">
              <a:extLst>
                <a:ext uri="{FF2B5EF4-FFF2-40B4-BE49-F238E27FC236}">
                  <a16:creationId xmlns:a16="http://schemas.microsoft.com/office/drawing/2014/main" id="{EA7C4A99-481F-AA4E-AAC1-E2FDD2C361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4005" y="295527"/>
              <a:ext cx="3453523" cy="553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YMV TLS cleavage by </a:t>
              </a:r>
              <a:r>
                <a:rPr kumimoji="0" lang="en-GB" altLang="fr-FR" sz="1000" b="1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ytoRP</a:t>
              </a:r>
              <a:endParaRPr kumimoji="0" lang="en-GB" altLang="fr-FR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 </a:t>
              </a:r>
              <a:r>
                <a:rPr lang="en-GB" altLang="fr-FR" sz="1000" dirty="0">
                  <a:latin typeface="Symbol" pitchFamily="2" charset="2"/>
                  <a:ea typeface="Cambria" panose="02040503050406030204" pitchFamily="18" charset="0"/>
                  <a:cs typeface="Arial" panose="020B0604020202020204" pitchFamily="34" charset="0"/>
                </a:rPr>
                <a:t>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 protein / 120 </a:t>
              </a:r>
              <a:r>
                <a:rPr lang="en-GB" altLang="fr-FR" sz="10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M</a:t>
              </a: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RNA</a:t>
              </a: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fr-FR" sz="10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Triplicate experiments R1 to R3</a:t>
              </a:r>
            </a:p>
          </p:txBody>
        </p: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8A07619-44CD-A34E-BABD-DECE2CD5262C}"/>
                </a:ext>
              </a:extLst>
            </p:cNvPr>
            <p:cNvGrpSpPr/>
            <p:nvPr/>
          </p:nvGrpSpPr>
          <p:grpSpPr>
            <a:xfrm>
              <a:off x="1204164" y="1057558"/>
              <a:ext cx="4244154" cy="2846728"/>
              <a:chOff x="1257327" y="1971958"/>
              <a:chExt cx="4244154" cy="2846728"/>
            </a:xfrm>
          </p:grpSpPr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1CD8EFEF-5356-164E-82C7-5794F3DF5BD6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EFDFACDC-CD59-954C-A933-FCD9A290A62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C323F6B9-8AAE-C24B-A6BF-C59F5A62134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6993A487-8E66-1946-942C-5646EA7ABBC6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0DBBF5C4-7F50-B341-8445-D037A0559FAE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125189E-842E-A946-98C8-49F4142D064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9B066AB0-6F04-3D4F-BAF8-10344580BE41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65FE8C84-A825-B945-9BB7-4EB11398D95A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6D0736BB-3C0C-D841-9A64-2C6A5C02A5E2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DBA9A2E2-0B24-5A42-B1CC-EDB4A09AEB11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DAB21B84-4E37-8047-88BD-955827AD24FE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DD3CE217-7B1E-704E-8976-D1CDA3830A4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39FE8BB3-DD68-254C-879B-8810B74803BE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8CC45070-D7DA-F547-9DA3-603D0054AA63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54179858-7C67-8A4C-AEF0-9DC2FAFB7701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F211E55F-55D3-864B-863D-5D2C452A1203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88BC769D-4E96-DE4F-A4E4-821D37CC22B8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AB0212F0-A720-F943-ACD6-06AE0CCD4920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64" name="Image 63">
                  <a:extLst>
                    <a:ext uri="{FF2B5EF4-FFF2-40B4-BE49-F238E27FC236}">
                      <a16:creationId xmlns:a16="http://schemas.microsoft.com/office/drawing/2014/main" id="{38AC4057-C7BF-9643-9DA2-347DDDEFCC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66" name="Image 65">
                  <a:extLst>
                    <a:ext uri="{FF2B5EF4-FFF2-40B4-BE49-F238E27FC236}">
                      <a16:creationId xmlns:a16="http://schemas.microsoft.com/office/drawing/2014/main" id="{DBCE41FC-2FAD-EB40-B1C9-422739AC8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6BF9F8BE-DD35-0344-BD4C-91B681CCFE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50794468-9A38-1044-871C-AF75BC97CA45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43985BD9-4425-0648-981F-08B905D71490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8" name="Groupe 57">
              <a:extLst>
                <a:ext uri="{FF2B5EF4-FFF2-40B4-BE49-F238E27FC236}">
                  <a16:creationId xmlns:a16="http://schemas.microsoft.com/office/drawing/2014/main" id="{1D8F4CD4-58F7-3F40-A0EE-C42CAAE20FE2}"/>
                </a:ext>
              </a:extLst>
            </p:cNvPr>
            <p:cNvGrpSpPr/>
            <p:nvPr/>
          </p:nvGrpSpPr>
          <p:grpSpPr>
            <a:xfrm>
              <a:off x="1172986" y="4125773"/>
              <a:ext cx="4244154" cy="2846728"/>
              <a:chOff x="1257327" y="1971958"/>
              <a:chExt cx="4244154" cy="2846728"/>
            </a:xfrm>
          </p:grpSpPr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0A7AC235-9304-F24D-B8AF-1E058AB11382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9FFB546C-CBE8-CE49-A73B-278DC9296270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61" name="ZoneTexte 60">
                <a:extLst>
                  <a:ext uri="{FF2B5EF4-FFF2-40B4-BE49-F238E27FC236}">
                    <a16:creationId xmlns:a16="http://schemas.microsoft.com/office/drawing/2014/main" id="{6FD0A9B3-4766-674C-9D50-DA05A7798060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9E091E4B-42CE-754F-AF1A-53D444EC20E4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3D4A7D48-A67B-D848-AEE8-52C89C2E739A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921B5D59-13EF-F842-81F5-FAE8CA68C1F1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F534B04A-3346-FF42-9F18-FEBFBFDB309C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3A4CFCA9-BA91-3841-A28D-23055B1FB84E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79D80894-EFA9-204B-8519-AE852C886BFD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7707D6A1-2C20-D64C-93EB-DF43B992D80B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7CB1498C-A8D9-AA40-B736-DA403DF05200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1276C0CC-92A9-1141-865A-677840F4DD00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DB99AB2-89C0-6244-AFF1-4F53BB1BBD6B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E2792A8E-239C-4447-9072-4BA2E3451862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C725275E-AD8D-D24B-A838-04B3ABE6F41C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06" name="Groupe 105">
                <a:extLst>
                  <a:ext uri="{FF2B5EF4-FFF2-40B4-BE49-F238E27FC236}">
                    <a16:creationId xmlns:a16="http://schemas.microsoft.com/office/drawing/2014/main" id="{076DCC62-5C55-C847-BA78-2BF567EDA64C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08" name="ZoneTexte 107">
                  <a:extLst>
                    <a:ext uri="{FF2B5EF4-FFF2-40B4-BE49-F238E27FC236}">
                      <a16:creationId xmlns:a16="http://schemas.microsoft.com/office/drawing/2014/main" id="{AEEA32C9-137A-0A46-9A5B-262035D2B370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65116725-6946-5F43-85E0-5CE1F022EDA5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10" name="Image 109">
                  <a:extLst>
                    <a:ext uri="{FF2B5EF4-FFF2-40B4-BE49-F238E27FC236}">
                      <a16:creationId xmlns:a16="http://schemas.microsoft.com/office/drawing/2014/main" id="{57F48C3B-558B-8E48-9EA7-D5EF7555AB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7B87F8D6-0EEB-C648-9994-98E7849656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BDB563D0-97A3-7146-9818-801E41654570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3" name="ZoneTexte 112">
                  <a:extLst>
                    <a:ext uri="{FF2B5EF4-FFF2-40B4-BE49-F238E27FC236}">
                      <a16:creationId xmlns:a16="http://schemas.microsoft.com/office/drawing/2014/main" id="{34FF9EAF-4DD2-1442-BF19-451FCBAA39A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F562B0E1-400A-8044-A4AC-3C0676ECE766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4" name="Groupe 113">
              <a:extLst>
                <a:ext uri="{FF2B5EF4-FFF2-40B4-BE49-F238E27FC236}">
                  <a16:creationId xmlns:a16="http://schemas.microsoft.com/office/drawing/2014/main" id="{01BE6746-B016-5842-A93A-E46A394D5BB0}"/>
                </a:ext>
              </a:extLst>
            </p:cNvPr>
            <p:cNvGrpSpPr/>
            <p:nvPr/>
          </p:nvGrpSpPr>
          <p:grpSpPr>
            <a:xfrm>
              <a:off x="1141808" y="7193988"/>
              <a:ext cx="4244154" cy="2846728"/>
              <a:chOff x="1257327" y="1971958"/>
              <a:chExt cx="4244154" cy="2846728"/>
            </a:xfrm>
          </p:grpSpPr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0BE5CDCB-693A-4444-84FE-4F5911D209AE}"/>
                  </a:ext>
                </a:extLst>
              </p:cNvPr>
              <p:cNvSpPr txBox="1"/>
              <p:nvPr/>
            </p:nvSpPr>
            <p:spPr>
              <a:xfrm>
                <a:off x="5098894" y="197195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64104D1-7CE2-384B-BD6D-808C406AC5DA}"/>
                  </a:ext>
                </a:extLst>
              </p:cNvPr>
              <p:cNvSpPr txBox="1"/>
              <p:nvPr/>
            </p:nvSpPr>
            <p:spPr>
              <a:xfrm>
                <a:off x="5105219" y="231266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A2D2FEB2-AE18-254F-B200-080757F8B3FB}"/>
                  </a:ext>
                </a:extLst>
              </p:cNvPr>
              <p:cNvSpPr txBox="1"/>
              <p:nvPr/>
            </p:nvSpPr>
            <p:spPr>
              <a:xfrm>
                <a:off x="5105092" y="265447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6BFBD3CE-C02D-2C4E-86B2-4C2A4A209BDC}"/>
                  </a:ext>
                </a:extLst>
              </p:cNvPr>
              <p:cNvSpPr txBox="1"/>
              <p:nvPr/>
            </p:nvSpPr>
            <p:spPr>
              <a:xfrm>
                <a:off x="5107473" y="308052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53F2ED0A-5071-524A-941F-8E04D129D711}"/>
                  </a:ext>
                </a:extLst>
              </p:cNvPr>
              <p:cNvSpPr txBox="1"/>
              <p:nvPr/>
            </p:nvSpPr>
            <p:spPr>
              <a:xfrm>
                <a:off x="5090045" y="393584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430B1881-51C6-DD45-BBC3-CCE498297E72}"/>
                  </a:ext>
                </a:extLst>
              </p:cNvPr>
              <p:cNvSpPr txBox="1"/>
              <p:nvPr/>
            </p:nvSpPr>
            <p:spPr>
              <a:xfrm>
                <a:off x="2809700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25" name="ZoneTexte 124">
                <a:extLst>
                  <a:ext uri="{FF2B5EF4-FFF2-40B4-BE49-F238E27FC236}">
                    <a16:creationId xmlns:a16="http://schemas.microsoft.com/office/drawing/2014/main" id="{F7129E0D-E56A-F144-8FF8-BC5856AD4882}"/>
                  </a:ext>
                </a:extLst>
              </p:cNvPr>
              <p:cNvSpPr txBox="1"/>
              <p:nvPr/>
            </p:nvSpPr>
            <p:spPr>
              <a:xfrm>
                <a:off x="402155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1642B022-4F64-F940-948B-45C1AE556A93}"/>
                  </a:ext>
                </a:extLst>
              </p:cNvPr>
              <p:cNvSpPr txBox="1"/>
              <p:nvPr/>
            </p:nvSpPr>
            <p:spPr>
              <a:xfrm>
                <a:off x="189089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fr-F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D5756056-3A95-E945-9D7E-3A8F5BB66091}"/>
                  </a:ext>
                </a:extLst>
              </p:cNvPr>
              <p:cNvSpPr txBox="1"/>
              <p:nvPr/>
            </p:nvSpPr>
            <p:spPr>
              <a:xfrm>
                <a:off x="4319072" y="2009363"/>
                <a:ext cx="495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A01687C9-A5A3-F04D-9E97-7DC346F9FCAA}"/>
                  </a:ext>
                </a:extLst>
              </p:cNvPr>
              <p:cNvSpPr txBox="1"/>
              <p:nvPr/>
            </p:nvSpPr>
            <p:spPr>
              <a:xfrm>
                <a:off x="4621193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2B85A178-DA47-4F43-B265-CA926B73A972}"/>
                  </a:ext>
                </a:extLst>
              </p:cNvPr>
              <p:cNvSpPr txBox="1"/>
              <p:nvPr/>
            </p:nvSpPr>
            <p:spPr>
              <a:xfrm>
                <a:off x="3422035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1BDFE279-9843-0540-9FE1-52145DCAA19F}"/>
                  </a:ext>
                </a:extLst>
              </p:cNvPr>
              <p:cNvSpPr txBox="1"/>
              <p:nvPr/>
            </p:nvSpPr>
            <p:spPr>
              <a:xfrm>
                <a:off x="220802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E4919AF2-E58B-0041-9B5D-3621E54E5EE7}"/>
                  </a:ext>
                </a:extLst>
              </p:cNvPr>
              <p:cNvSpPr txBox="1"/>
              <p:nvPr/>
            </p:nvSpPr>
            <p:spPr>
              <a:xfrm>
                <a:off x="2530109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2CA6D92-2EC9-1741-8268-C92E918FE638}"/>
                  </a:ext>
                </a:extLst>
              </p:cNvPr>
              <p:cNvSpPr txBox="1"/>
              <p:nvPr/>
            </p:nvSpPr>
            <p:spPr>
              <a:xfrm>
                <a:off x="3727134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1C1EDCC1-A17A-5C4E-B458-624A14370618}"/>
                  </a:ext>
                </a:extLst>
              </p:cNvPr>
              <p:cNvSpPr txBox="1"/>
              <p:nvPr/>
            </p:nvSpPr>
            <p:spPr>
              <a:xfrm>
                <a:off x="3104342" y="2009363"/>
                <a:ext cx="444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pSp>
            <p:nvGrpSpPr>
              <p:cNvPr id="134" name="Groupe 133">
                <a:extLst>
                  <a:ext uri="{FF2B5EF4-FFF2-40B4-BE49-F238E27FC236}">
                    <a16:creationId xmlns:a16="http://schemas.microsoft.com/office/drawing/2014/main" id="{26ECCB30-FA84-964B-A1EA-A67E6FC44FB2}"/>
                  </a:ext>
                </a:extLst>
              </p:cNvPr>
              <p:cNvGrpSpPr/>
              <p:nvPr/>
            </p:nvGrpSpPr>
            <p:grpSpPr>
              <a:xfrm>
                <a:off x="1257327" y="2400105"/>
                <a:ext cx="575898" cy="1267129"/>
                <a:chOff x="1257327" y="2446997"/>
                <a:chExt cx="575898" cy="1267129"/>
              </a:xfrm>
            </p:grpSpPr>
            <p:sp>
              <p:nvSpPr>
                <p:cNvPr id="136" name="ZoneTexte 135">
                  <a:extLst>
                    <a:ext uri="{FF2B5EF4-FFF2-40B4-BE49-F238E27FC236}">
                      <a16:creationId xmlns:a16="http://schemas.microsoft.com/office/drawing/2014/main" id="{5C53C698-EBF5-5C4F-85FA-80FC01A95E69}"/>
                    </a:ext>
                  </a:extLst>
                </p:cNvPr>
                <p:cNvSpPr txBox="1"/>
                <p:nvPr/>
              </p:nvSpPr>
              <p:spPr>
                <a:xfrm>
                  <a:off x="1321584" y="2446997"/>
                  <a:ext cx="4545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12</a:t>
                  </a:r>
                </a:p>
                <a:p>
                  <a:pPr algn="r"/>
                  <a:endParaRPr lang="fr-FR" sz="800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18444258-8F77-A24B-B44A-48CCC110D53A}"/>
                    </a:ext>
                  </a:extLst>
                </p:cNvPr>
                <p:cNvSpPr txBox="1"/>
                <p:nvPr/>
              </p:nvSpPr>
              <p:spPr>
                <a:xfrm>
                  <a:off x="1345133" y="3437127"/>
                  <a:ext cx="3647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200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92</a:t>
                  </a:r>
                </a:p>
              </p:txBody>
            </p:sp>
            <p:pic>
              <p:nvPicPr>
                <p:cNvPr id="138" name="Image 137">
                  <a:extLst>
                    <a:ext uri="{FF2B5EF4-FFF2-40B4-BE49-F238E27FC236}">
                      <a16:creationId xmlns:a16="http://schemas.microsoft.com/office/drawing/2014/main" id="{3D1CAAC4-3732-1A44-BA83-7F1123F431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45480" y="2645103"/>
                  <a:ext cx="387745" cy="440143"/>
                </a:xfrm>
                <a:prstGeom prst="rect">
                  <a:avLst/>
                </a:prstGeom>
              </p:spPr>
            </p:pic>
            <p:pic>
              <p:nvPicPr>
                <p:cNvPr id="139" name="Image 138">
                  <a:extLst>
                    <a:ext uri="{FF2B5EF4-FFF2-40B4-BE49-F238E27FC236}">
                      <a16:creationId xmlns:a16="http://schemas.microsoft.com/office/drawing/2014/main" id="{7742E69C-24E4-214A-A14E-90CD0DC3C3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453731" y="3075599"/>
                  <a:ext cx="307393" cy="385544"/>
                </a:xfrm>
                <a:prstGeom prst="rect">
                  <a:avLst/>
                </a:prstGeom>
              </p:spPr>
            </p:pic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6057A902-73E3-2445-9BB8-096D5C0A05AA}"/>
                    </a:ext>
                  </a:extLst>
                </p:cNvPr>
                <p:cNvSpPr txBox="1"/>
                <p:nvPr/>
              </p:nvSpPr>
              <p:spPr>
                <a:xfrm>
                  <a:off x="1257327" y="2729568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41" name="ZoneTexte 140">
                  <a:extLst>
                    <a:ext uri="{FF2B5EF4-FFF2-40B4-BE49-F238E27FC236}">
                      <a16:creationId xmlns:a16="http://schemas.microsoft.com/office/drawing/2014/main" id="{798D82BA-B222-2847-A7C1-6A5CE590991C}"/>
                    </a:ext>
                  </a:extLst>
                </p:cNvPr>
                <p:cNvSpPr txBox="1"/>
                <p:nvPr/>
              </p:nvSpPr>
              <p:spPr>
                <a:xfrm>
                  <a:off x="1263232" y="3144881"/>
                  <a:ext cx="2584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A1E7001-889B-064E-A173-C511D3446E6E}"/>
                  </a:ext>
                </a:extLst>
              </p:cNvPr>
              <p:cNvSpPr/>
              <p:nvPr/>
            </p:nvSpPr>
            <p:spPr>
              <a:xfrm>
                <a:off x="1877038" y="2225823"/>
                <a:ext cx="3274248" cy="259286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2" name="Rectangle 3">
              <a:extLst>
                <a:ext uri="{FF2B5EF4-FFF2-40B4-BE49-F238E27FC236}">
                  <a16:creationId xmlns:a16="http://schemas.microsoft.com/office/drawing/2014/main" id="{6701102F-22EC-E94E-BABC-6369F23019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39" y="1077290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1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">
              <a:extLst>
                <a:ext uri="{FF2B5EF4-FFF2-40B4-BE49-F238E27FC236}">
                  <a16:creationId xmlns:a16="http://schemas.microsoft.com/office/drawing/2014/main" id="{91C7B696-95EE-3244-8088-551F1FA51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080" y="4179479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2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3">
              <a:extLst>
                <a:ext uri="{FF2B5EF4-FFF2-40B4-BE49-F238E27FC236}">
                  <a16:creationId xmlns:a16="http://schemas.microsoft.com/office/drawing/2014/main" id="{5B013E50-06D9-3147-9E75-F83F94008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59" y="7203475"/>
              <a:ext cx="504681" cy="5232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fr-FR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3</a:t>
              </a: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  <a:p>
              <a:pPr lvl="0" algn="just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GB" altLang="fr-FR" sz="14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37791492-4DB5-8241-89AD-818E61ED0B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477" b="24358"/>
            <a:stretch/>
          </p:blipFill>
          <p:spPr>
            <a:xfrm>
              <a:off x="1858274" y="1324876"/>
              <a:ext cx="3199202" cy="2542005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DB0719D6-5E7D-2B49-8C25-A3092D9E90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1933" b="16434"/>
            <a:stretch/>
          </p:blipFill>
          <p:spPr>
            <a:xfrm>
              <a:off x="1837729" y="4409400"/>
              <a:ext cx="3202686" cy="2516184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087751E2-AB9D-D143-96FE-244DC3F293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4000"/>
                      </a14:imgEffect>
                    </a14:imgLayer>
                  </a14:imgProps>
                </a:ext>
              </a:extLst>
            </a:blip>
            <a:srcRect t="9636" b="26763"/>
            <a:stretch/>
          </p:blipFill>
          <p:spPr>
            <a:xfrm>
              <a:off x="1797300" y="7477614"/>
              <a:ext cx="3202686" cy="25426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70351377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par>
              <p:cTn id="3"/>
            </p:par>
          </p:childTnLst>
        </p:cTn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9</TotalTime>
  <Words>616</Words>
  <Application>Microsoft Macintosh PowerPoint</Application>
  <PresentationFormat>Grand écran</PresentationFormat>
  <Paragraphs>504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4" baseType="lpstr">
      <vt:lpstr>Arial</vt:lpstr>
      <vt:lpstr>Arial Narrow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Microsoft Office</cp:lastModifiedBy>
  <cp:revision>102</cp:revision>
  <cp:lastPrinted>2020-10-22T15:54:53Z</cp:lastPrinted>
  <dcterms:created xsi:type="dcterms:W3CDTF">2019-02-27T07:59:09Z</dcterms:created>
  <dcterms:modified xsi:type="dcterms:W3CDTF">2021-01-21T14:31:53Z</dcterms:modified>
</cp:coreProperties>
</file>